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66" d="100"/>
          <a:sy n="66" d="100"/>
        </p:scale>
        <p:origin x="1998" y="-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951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667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93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639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802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599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709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430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38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461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437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FBCEE-CA92-40A5-BB88-BF5AF68E37FC}" type="datetimeFigureOut">
              <a:rPr lang="en-US" smtClean="0"/>
              <a:t>10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E7F71-00EB-429E-9474-D0A0D23CE9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07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6148" y="1250301"/>
            <a:ext cx="3142297" cy="663185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45537" y="7995295"/>
            <a:ext cx="606723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air bundl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at detached from the skin of cattle as the tick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picked;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amaged cattle skin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at was easily detached with the tick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piece of damaged skin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irmly attached to the mouth part thus altering the gross morphological appearance of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phal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 of tick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farmer considered these “new” species of tick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45537" y="460315"/>
            <a:ext cx="584329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ure S2.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lang="en-US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coloratus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cked from cattle with acaricide induced skin damage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47261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101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P</dc:creator>
  <cp:lastModifiedBy>VP</cp:lastModifiedBy>
  <cp:revision>7</cp:revision>
  <dcterms:created xsi:type="dcterms:W3CDTF">2015-08-25T05:02:26Z</dcterms:created>
  <dcterms:modified xsi:type="dcterms:W3CDTF">2015-10-30T14:52:31Z</dcterms:modified>
</cp:coreProperties>
</file>